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3150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6182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488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02177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240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5042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6578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653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698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900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0368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327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9885" y="1102716"/>
            <a:ext cx="8151431" cy="43396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ouse</a:t>
            </a:r>
            <a:r>
              <a:rPr lang="en-US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1    </a:t>
            </a:r>
            <a:r>
              <a:rPr lang="en-US" sz="1200" b="1" u="sng" dirty="0">
                <a:latin typeface="Courier New" panose="02070309020205020404" pitchFamily="49" charset="0"/>
                <a:cs typeface="Courier New" panose="02070309020205020404" pitchFamily="49" charset="0"/>
              </a:rPr>
              <a:t>MKLPKAQLWLILLWALVWVQS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TRSACPSCGGPTLAPQGERALVLELAKQQILEGLHLTSR  60</a:t>
            </a:r>
          </a:p>
          <a:p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M+LP  QLWL+LLWALV  Q T S CPSCGG  LAPQ ERALVLELAKQQIL+GLHLTSR</a:t>
            </a:r>
          </a:p>
          <a:p>
            <a:r>
              <a:rPr lang="en-US" sz="1200" b="1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uman</a:t>
            </a:r>
            <a:r>
              <a:rPr lang="en-US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1    </a:t>
            </a:r>
            <a:r>
              <a:rPr lang="en-US" sz="1200" b="1" u="sng" dirty="0">
                <a:latin typeface="Courier New" panose="02070309020205020404" pitchFamily="49" charset="0"/>
                <a:cs typeface="Courier New" panose="02070309020205020404" pitchFamily="49" charset="0"/>
              </a:rPr>
              <a:t>MRLPDVQLWLVLLWALVRA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QGTGSVCPSCGGSKLAPQAERALVLELAKQQILDGLHLTSR  60</a:t>
            </a:r>
          </a:p>
          <a:p>
            <a:endParaRPr lang="en-US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1200" b="1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ouse</a:t>
            </a:r>
            <a:r>
              <a:rPr lang="en-US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61   PRITRPLPQAALTRALRRLQPKSMVPGNREKVISFATIIDKSTSTYRSMLTFQLSPLWSH  120</a:t>
            </a:r>
          </a:p>
          <a:p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PRIT P PQAALTRALRRLQP S+ PGN E+VISFAT+ D STS Y S+LTF LS   SH</a:t>
            </a:r>
          </a:p>
          <a:p>
            <a:r>
              <a:rPr lang="en-US" sz="1200" b="1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uman</a:t>
            </a:r>
            <a:r>
              <a:rPr lang="en-US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61   PRITHPPPQAALTRALRRLQPGSVAPGNGEEVISFATVTD-STSAYSSLLTFHLSTPRSH  119</a:t>
            </a:r>
          </a:p>
          <a:p>
            <a:endParaRPr lang="en-US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1200" b="1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ouse</a:t>
            </a:r>
            <a:r>
              <a:rPr lang="en-US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121  HLYHARLWLHVPPSFPGTLYLRIFRCGTTRCR-GFRTFLAEHQTTSSGWHALTLPSSGLR  179</a:t>
            </a:r>
          </a:p>
          <a:p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HLYHARLWLHV P+ PGTL LRIFR G  R </a:t>
            </a:r>
            <a:r>
              <a:rPr lang="en-US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G RT LAEH  T+ GWH LTLPSSGLR</a:t>
            </a:r>
          </a:p>
          <a:p>
            <a:r>
              <a:rPr lang="en-US" sz="1200" b="1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uman</a:t>
            </a:r>
            <a:r>
              <a:rPr lang="en-US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120  HLYHARLWLHVLPTLPGTLCLRIFRWGPRRRRQGSRTLLAEHHITNLGWHTLTLPSSGLR  179</a:t>
            </a:r>
          </a:p>
          <a:p>
            <a:endParaRPr lang="en-US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1200" b="1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ouse</a:t>
            </a:r>
            <a:r>
              <a:rPr lang="en-US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180  SEDSGVVKLQLEFRPLDLNSTAAGLPRLLLDTAGQQRPFLELKIRANEPGAGRA</a:t>
            </a:r>
            <a:r>
              <a:rPr lang="en-US" sz="12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RR</a:t>
            </a:r>
            <a:r>
              <a:rPr lang="en-US" sz="1200" b="1" dirty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PT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239</a:t>
            </a:r>
          </a:p>
          <a:p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E SGV+KLQL+ RPL+ NST  G PR LLDTAG Q+PFLELKIRANEPGAGRARRRTPT</a:t>
            </a:r>
          </a:p>
          <a:p>
            <a:r>
              <a:rPr lang="en-US" sz="1200" b="1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uman</a:t>
            </a:r>
            <a:r>
              <a:rPr lang="en-US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180  GEKSGVLKLQLDCRPLEGNSTVTGQPRRLLDTAGHQQPFLELKIRANEPGAGRA</a:t>
            </a:r>
            <a:r>
              <a:rPr lang="en-US" sz="12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RR</a:t>
            </a:r>
            <a:r>
              <a:rPr lang="en-US" sz="1200" b="1" dirty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PT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239</a:t>
            </a:r>
          </a:p>
          <a:p>
            <a:endParaRPr lang="en-US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1200" b="1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ouse</a:t>
            </a:r>
            <a:r>
              <a:rPr lang="en-US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240  </a:t>
            </a:r>
            <a:r>
              <a:rPr lang="en-US" sz="1200" b="1" dirty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EPETPLCCRRDHYVDFQELGWRDWILQPEGYQLNYCSGQCPPHLAGSPGIAASFHSAVF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299</a:t>
            </a:r>
          </a:p>
          <a:p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CEP TPLCCRRDHYVDFQELGWRDWILQPEGYQLNYCSGQCPPHLAGSPGIAASFHSAVF</a:t>
            </a:r>
          </a:p>
          <a:p>
            <a:r>
              <a:rPr lang="en-US" sz="1200" b="1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uman</a:t>
            </a:r>
            <a:r>
              <a:rPr lang="en-US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240  </a:t>
            </a:r>
            <a:r>
              <a:rPr lang="en-US" sz="1200" b="1" dirty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EPATPLCCRRDHYVDFQELGWRDWILQPEGYQLNYCSGQCPPHLAGSPGIAASFHSAVF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299</a:t>
            </a:r>
          </a:p>
          <a:p>
            <a:endParaRPr lang="en-US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1200" b="1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ouse</a:t>
            </a:r>
            <a:r>
              <a:rPr lang="en-US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300  </a:t>
            </a:r>
            <a:r>
              <a:rPr lang="en-US" sz="1200" b="1" dirty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LLKANNPWPAGSSCCVPTARRPLSLLYLDHNGNVVKTDVPDMVVEACGCS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350</a:t>
            </a:r>
          </a:p>
          <a:p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SLLKANNPWPA +SCCVPTARRPLSLLYLDHNGNVVKTDVPDMVVEACGCS</a:t>
            </a:r>
          </a:p>
          <a:p>
            <a:r>
              <a:rPr lang="en-US" sz="1200" b="1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uman</a:t>
            </a:r>
            <a:r>
              <a:rPr lang="en-US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300  </a:t>
            </a:r>
            <a:r>
              <a:rPr lang="en-US" sz="1200" b="1" dirty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LLKANNPWPASTSCCVPTARRPLSLLYLDHNGNVVKTDVPDMVVEACGCS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350</a:t>
            </a:r>
          </a:p>
        </p:txBody>
      </p:sp>
      <p:sp>
        <p:nvSpPr>
          <p:cNvPr id="3" name="Rectangle 2"/>
          <p:cNvSpPr/>
          <p:nvPr/>
        </p:nvSpPr>
        <p:spPr>
          <a:xfrm>
            <a:off x="3420968" y="271606"/>
            <a:ext cx="512614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ouse vs Human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Activin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E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rotein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lignment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685026" y="6119079"/>
            <a:ext cx="8908211" cy="2899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4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. Amino acid alignment of full-length Act E proteins from mouse (accession NP_032408) and human (accession NP_113667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79331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9</TotalTime>
  <Words>136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</vt:vector>
  </TitlesOfParts>
  <Company>The Children's Hospital of Philadelph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llings, Paul C</dc:creator>
  <cp:lastModifiedBy>Billings, Paul C</cp:lastModifiedBy>
  <cp:revision>5</cp:revision>
  <dcterms:created xsi:type="dcterms:W3CDTF">2020-01-03T20:36:22Z</dcterms:created>
  <dcterms:modified xsi:type="dcterms:W3CDTF">2020-01-07T16:09:29Z</dcterms:modified>
</cp:coreProperties>
</file>